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62" r:id="rId5"/>
    <p:sldId id="260" r:id="rId6"/>
    <p:sldId id="261" r:id="rId7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9" d="100"/>
          <a:sy n="79" d="100"/>
        </p:scale>
        <p:origin x="72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lnSpc>
                <a:spcPct val="150000"/>
              </a:lnSpc>
              <a:defRPr sz="1100" b="0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it-IT" sz="110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rticle size (PS): ***</a:t>
            </a:r>
          </a:p>
          <a:p>
            <a:pPr>
              <a:lnSpc>
                <a:spcPct val="150000"/>
              </a:lnSpc>
              <a:defRPr sz="110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it-IT" sz="110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mpost rate (CR): ns</a:t>
            </a:r>
          </a:p>
          <a:p>
            <a:pPr>
              <a:lnSpc>
                <a:spcPct val="150000"/>
              </a:lnSpc>
              <a:defRPr sz="110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it-IT" sz="110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S x CR: **</a:t>
            </a:r>
          </a:p>
        </c:rich>
      </c:tx>
      <c:layout>
        <c:manualLayout>
          <c:xMode val="edge"/>
          <c:yMode val="edge"/>
          <c:x val="0.7978875916372522"/>
          <c:y val="0.5478867902248415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lnSpc>
              <a:spcPct val="150000"/>
            </a:lnSpc>
            <a:defRPr sz="1100" b="0" i="0" u="none" strike="noStrike" kern="1200" spc="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it-IT"/>
        </a:p>
      </c:txPr>
    </c:title>
    <c:autoTitleDeleted val="0"/>
    <c:plotArea>
      <c:layout>
        <c:manualLayout>
          <c:layoutTarget val="inner"/>
          <c:xMode val="edge"/>
          <c:yMode val="edge"/>
          <c:x val="0.13788010873640794"/>
          <c:y val="5.0925925925925923E-2"/>
          <c:w val="0.65455177477815263"/>
          <c:h val="0.85574416694845656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Argentiera!$A$208</c:f>
              <c:strCache>
                <c:ptCount val="1"/>
                <c:pt idx="0">
                  <c:v>50-2000 µm</c:v>
                </c:pt>
              </c:strCache>
            </c:strRef>
          </c:tx>
          <c:spPr>
            <a:solidFill>
              <a:schemeClr val="accent6">
                <a:lumMod val="40000"/>
                <a:lumOff val="60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it-IT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Argentiera!$B$207:$E$207</c:f>
              <c:strCache>
                <c:ptCount val="4"/>
                <c:pt idx="0">
                  <c:v>Control</c:v>
                </c:pt>
                <c:pt idx="1">
                  <c:v>MSWC1.5%</c:v>
                </c:pt>
                <c:pt idx="2">
                  <c:v>MSWC3.0%</c:v>
                </c:pt>
                <c:pt idx="3">
                  <c:v>MSWC4.5%</c:v>
                </c:pt>
              </c:strCache>
            </c:strRef>
          </c:cat>
          <c:val>
            <c:numRef>
              <c:f>Argentiera!$B$208:$E$208</c:f>
              <c:numCache>
                <c:formatCode>0%</c:formatCode>
                <c:ptCount val="4"/>
                <c:pt idx="0">
                  <c:v>0.77151212561748306</c:v>
                </c:pt>
                <c:pt idx="1">
                  <c:v>0.81695944636772011</c:v>
                </c:pt>
                <c:pt idx="2">
                  <c:v>0.81956381582221782</c:v>
                </c:pt>
                <c:pt idx="3">
                  <c:v>0.814304970055691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D40-420E-A595-C3858481A4F8}"/>
            </c:ext>
          </c:extLst>
        </c:ser>
        <c:ser>
          <c:idx val="1"/>
          <c:order val="1"/>
          <c:tx>
            <c:strRef>
              <c:f>Argentiera!$A$209</c:f>
              <c:strCache>
                <c:ptCount val="1"/>
                <c:pt idx="0">
                  <c:v>20-50 µm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it-IT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Argentiera!$B$207:$E$207</c:f>
              <c:strCache>
                <c:ptCount val="4"/>
                <c:pt idx="0">
                  <c:v>Control</c:v>
                </c:pt>
                <c:pt idx="1">
                  <c:v>MSWC1.5%</c:v>
                </c:pt>
                <c:pt idx="2">
                  <c:v>MSWC3.0%</c:v>
                </c:pt>
                <c:pt idx="3">
                  <c:v>MSWC4.5%</c:v>
                </c:pt>
              </c:strCache>
            </c:strRef>
          </c:cat>
          <c:val>
            <c:numRef>
              <c:f>Argentiera!$B$209:$E$209</c:f>
              <c:numCache>
                <c:formatCode>0%</c:formatCode>
                <c:ptCount val="4"/>
                <c:pt idx="0">
                  <c:v>4.6088544766583826E-2</c:v>
                </c:pt>
                <c:pt idx="1">
                  <c:v>3.9462635856290243E-2</c:v>
                </c:pt>
                <c:pt idx="2">
                  <c:v>4.2677341479195732E-2</c:v>
                </c:pt>
                <c:pt idx="3">
                  <c:v>4.34089478887084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D40-420E-A595-C3858481A4F8}"/>
            </c:ext>
          </c:extLst>
        </c:ser>
        <c:ser>
          <c:idx val="2"/>
          <c:order val="2"/>
          <c:tx>
            <c:strRef>
              <c:f>Argentiera!$A$210</c:f>
              <c:strCache>
                <c:ptCount val="1"/>
                <c:pt idx="0">
                  <c:v>10-20 µm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it-IT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Argentiera!$B$207:$E$207</c:f>
              <c:strCache>
                <c:ptCount val="4"/>
                <c:pt idx="0">
                  <c:v>Control</c:v>
                </c:pt>
                <c:pt idx="1">
                  <c:v>MSWC1.5%</c:v>
                </c:pt>
                <c:pt idx="2">
                  <c:v>MSWC3.0%</c:v>
                </c:pt>
                <c:pt idx="3">
                  <c:v>MSWC4.5%</c:v>
                </c:pt>
              </c:strCache>
            </c:strRef>
          </c:cat>
          <c:val>
            <c:numRef>
              <c:f>Argentiera!$B$210:$E$210</c:f>
              <c:numCache>
                <c:formatCode>0%</c:formatCode>
                <c:ptCount val="4"/>
                <c:pt idx="0">
                  <c:v>4.3843305105201735E-2</c:v>
                </c:pt>
                <c:pt idx="1">
                  <c:v>3.1301384092626644E-2</c:v>
                </c:pt>
                <c:pt idx="2">
                  <c:v>3.5237303404340073E-2</c:v>
                </c:pt>
                <c:pt idx="3">
                  <c:v>4.255221237146077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D40-420E-A595-C3858481A4F8}"/>
            </c:ext>
          </c:extLst>
        </c:ser>
        <c:ser>
          <c:idx val="3"/>
          <c:order val="3"/>
          <c:tx>
            <c:strRef>
              <c:f>Argentiera!$A$211</c:f>
              <c:strCache>
                <c:ptCount val="1"/>
                <c:pt idx="0">
                  <c:v>2-10 µm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it-IT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Argentiera!$B$207:$E$207</c:f>
              <c:strCache>
                <c:ptCount val="4"/>
                <c:pt idx="0">
                  <c:v>Control</c:v>
                </c:pt>
                <c:pt idx="1">
                  <c:v>MSWC1.5%</c:v>
                </c:pt>
                <c:pt idx="2">
                  <c:v>MSWC3.0%</c:v>
                </c:pt>
                <c:pt idx="3">
                  <c:v>MSWC4.5%</c:v>
                </c:pt>
              </c:strCache>
            </c:strRef>
          </c:cat>
          <c:val>
            <c:numRef>
              <c:f>Argentiera!$B$211:$E$211</c:f>
              <c:numCache>
                <c:formatCode>0%</c:formatCode>
                <c:ptCount val="4"/>
                <c:pt idx="0">
                  <c:v>8.2806312215255806E-2</c:v>
                </c:pt>
                <c:pt idx="1">
                  <c:v>4.43414096470999E-2</c:v>
                </c:pt>
                <c:pt idx="2">
                  <c:v>4.6936624278319766E-2</c:v>
                </c:pt>
                <c:pt idx="3">
                  <c:v>5.418551077022527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2D40-420E-A595-C3858481A4F8}"/>
            </c:ext>
          </c:extLst>
        </c:ser>
        <c:ser>
          <c:idx val="4"/>
          <c:order val="4"/>
          <c:tx>
            <c:strRef>
              <c:f>Argentiera!$A$212</c:f>
              <c:strCache>
                <c:ptCount val="1"/>
                <c:pt idx="0">
                  <c:v>&lt;2 µm</c:v>
                </c:pt>
              </c:strCache>
            </c:strRef>
          </c:tx>
          <c:spPr>
            <a:solidFill>
              <a:schemeClr val="accent5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it-IT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Argentiera!$B$207:$E$207</c:f>
              <c:strCache>
                <c:ptCount val="4"/>
                <c:pt idx="0">
                  <c:v>Control</c:v>
                </c:pt>
                <c:pt idx="1">
                  <c:v>MSWC1.5%</c:v>
                </c:pt>
                <c:pt idx="2">
                  <c:v>MSWC3.0%</c:v>
                </c:pt>
                <c:pt idx="3">
                  <c:v>MSWC4.5%</c:v>
                </c:pt>
              </c:strCache>
            </c:strRef>
          </c:cat>
          <c:val>
            <c:numRef>
              <c:f>Argentiera!$B$212:$E$212</c:f>
              <c:numCache>
                <c:formatCode>0%</c:formatCode>
                <c:ptCount val="4"/>
                <c:pt idx="0">
                  <c:v>5.5749712295475512E-2</c:v>
                </c:pt>
                <c:pt idx="1">
                  <c:v>6.7935124036262978E-2</c:v>
                </c:pt>
                <c:pt idx="2">
                  <c:v>5.5584915015926779E-2</c:v>
                </c:pt>
                <c:pt idx="3">
                  <c:v>4.5548358913914594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2D40-420E-A595-C3858481A4F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26619759"/>
        <c:axId val="226621423"/>
      </c:barChart>
      <c:catAx>
        <c:axId val="22661975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it-IT"/>
          </a:p>
        </c:txPr>
        <c:crossAx val="226621423"/>
        <c:crosses val="autoZero"/>
        <c:auto val="1"/>
        <c:lblAlgn val="ctr"/>
        <c:lblOffset val="100"/>
        <c:noMultiLvlLbl val="0"/>
      </c:catAx>
      <c:valAx>
        <c:axId val="226621423"/>
        <c:scaling>
          <c:orientation val="minMax"/>
          <c:max val="1"/>
        </c:scaling>
        <c:delete val="0"/>
        <c:axPos val="l"/>
        <c:numFmt formatCode="0%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it-IT"/>
          </a:p>
        </c:txPr>
        <c:crossAx val="22661975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81781850544543999"/>
          <c:y val="3.3128619658738978E-2"/>
          <c:w val="0.16385184152865848"/>
          <c:h val="0.3224615021281849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it-IT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A74284B-DA28-431C-ABC3-41C6DE20F3F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A0EA807D-D5E2-4632-AE49-B36C849F51E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092EA00-5D8E-4D9C-A68E-33ADA48F96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5D926-39A7-4300-960B-9D4FBD3AD3CF}" type="datetimeFigureOut">
              <a:rPr lang="it-IT" smtClean="0"/>
              <a:t>29/09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E822F6C-1F39-4144-8B80-BF8E4C90DD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7D63237-1B1B-4336-A26E-2AE2761785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8C10C5-4350-47AF-9CEE-A9845151BF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869031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2B35605-DCB6-4964-8E45-5D3E33DB76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54D7CB51-5146-4340-B7CC-39D722B69A0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D33A4A0-5BB8-4F69-B5F9-1DB18F3323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5D926-39A7-4300-960B-9D4FBD3AD3CF}" type="datetimeFigureOut">
              <a:rPr lang="it-IT" smtClean="0"/>
              <a:t>29/09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BE531E7-E43D-4209-959A-25CBB9DA3F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05EC606-F9F5-4C79-9248-518364A0F9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8C10C5-4350-47AF-9CEE-A9845151BF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27173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A98080F9-426B-4EA0-80FE-CB397ED384C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3A54F654-1ADD-41D6-93FA-DED8C39089E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7793559-C649-4B4D-A3EA-F4118E088A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5D926-39A7-4300-960B-9D4FBD3AD3CF}" type="datetimeFigureOut">
              <a:rPr lang="it-IT" smtClean="0"/>
              <a:t>29/09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7C3BD45-CC3D-4F0A-9C28-7E50AAA4C3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2F522C2-8396-4CC2-812E-7438B32E82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8C10C5-4350-47AF-9CEE-A9845151BF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053824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13BBAEA-359B-4C40-B02C-F872E2E402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C61ACCF8-24DB-4231-9DBB-C2843329627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690C619-FF68-49A3-B8FA-A880FD2B90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5D926-39A7-4300-960B-9D4FBD3AD3CF}" type="datetimeFigureOut">
              <a:rPr lang="it-IT" smtClean="0"/>
              <a:t>29/09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038700C-4C23-44CD-92A4-41F5748215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D5C2E29-FD15-42D1-9B80-2727EAE1CE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8C10C5-4350-47AF-9CEE-A9845151BF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022074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1712BBC-AADB-43E0-8F4E-4CD5E14043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24741C58-819F-4D81-BD0C-EFE96069D3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61440DC-1991-41C8-BF80-FA3741644E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5D926-39A7-4300-960B-9D4FBD3AD3CF}" type="datetimeFigureOut">
              <a:rPr lang="it-IT" smtClean="0"/>
              <a:t>29/09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6E83115-B6AA-4E48-9860-0613BA62CF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3B322E9-4500-493F-ABC7-45DA7DEF9D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8C10C5-4350-47AF-9CEE-A9845151BF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44394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B4862C7-1349-4CD4-82DA-505202108C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118B849A-2178-4D56-9362-6800BBD8BBE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79E83428-9B5D-40A3-A577-223FEBC14B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D2CC6E68-F11E-4FB6-B264-6F8E6910AE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5D926-39A7-4300-960B-9D4FBD3AD3CF}" type="datetimeFigureOut">
              <a:rPr lang="it-IT" smtClean="0"/>
              <a:t>29/09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299D7C4-C60A-4806-AA03-EDD66B1D00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C7267DE8-765B-4DF5-B20E-B5DDB78AD8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8C10C5-4350-47AF-9CEE-A9845151BF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832629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A25E173-DCB2-4BBE-8C0C-3A82C8070C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671C4E7-B9AF-4E8D-A892-E7E363F2C7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6B99CF2D-F2F9-4653-B334-1322ADDF0D6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F27DE0F6-1163-49FC-AAC4-70714864C1C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DFCE89AB-5C5B-431B-B214-C125CE7D198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F8EDCD88-1D4C-4C0E-9D27-9C7A70FF74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5D926-39A7-4300-960B-9D4FBD3AD3CF}" type="datetimeFigureOut">
              <a:rPr lang="it-IT" smtClean="0"/>
              <a:t>29/09/2023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AC437E2C-DCB3-45C2-8AAF-DE13C5457B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8F36F12F-6745-4337-BD83-9E14F75222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8C10C5-4350-47AF-9CEE-A9845151BF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107417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5986211-2A53-44F5-84D2-A7235F23D0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85E051EE-C793-432F-B341-0702BE6B00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5D926-39A7-4300-960B-9D4FBD3AD3CF}" type="datetimeFigureOut">
              <a:rPr lang="it-IT" smtClean="0"/>
              <a:t>29/09/2023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A487CD76-7694-4042-B021-AB6E27F0DA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19BADD16-1D53-4029-BECC-8FB378DAEF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8C10C5-4350-47AF-9CEE-A9845151BF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201973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3DE903C3-14B6-4E45-A618-8E30FB53A8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5D926-39A7-4300-960B-9D4FBD3AD3CF}" type="datetimeFigureOut">
              <a:rPr lang="it-IT" smtClean="0"/>
              <a:t>29/09/2023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68DF4141-93DA-49EA-82DD-7F6DB123C3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6E5322C4-72F7-4473-A440-76A31A6623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8C10C5-4350-47AF-9CEE-A9845151BF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396724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6107E20-DDB7-422E-BF82-2CBEE6E578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5B472A14-D248-4837-8515-74A38DC745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3BB4FB79-E6E6-4A15-95A9-83D50875955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4B54C49D-F34F-484F-86D5-AA807CD994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5D926-39A7-4300-960B-9D4FBD3AD3CF}" type="datetimeFigureOut">
              <a:rPr lang="it-IT" smtClean="0"/>
              <a:t>29/09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7DC0C78-B154-4780-8878-7E5665B294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58DE0E95-9663-49C7-91A6-4F9EB893A8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8C10C5-4350-47AF-9CEE-A9845151BF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065143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F6FC5FF-C573-412A-888C-45B009A237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4F26A427-E46B-4CCB-8C07-5125804D051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B94CFB40-84C4-477A-AE52-A140CF2AF04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BB524EAB-76D1-490D-BE98-0942AE2B26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5D926-39A7-4300-960B-9D4FBD3AD3CF}" type="datetimeFigureOut">
              <a:rPr lang="it-IT" smtClean="0"/>
              <a:t>29/09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92979A79-5740-4343-A821-1BE88169A8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F3DE4718-D9B7-4AB1-B324-FDE5C3182D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8C10C5-4350-47AF-9CEE-A9845151BF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392493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D34C19CC-4339-4129-875C-BD12C278BB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9FB5980F-6224-4BC9-AB10-83FEC4B376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3BD5FEF-1D63-41BE-8B3C-51945FFF1B6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C5D926-39A7-4300-960B-9D4FBD3AD3CF}" type="datetimeFigureOut">
              <a:rPr lang="it-IT" smtClean="0"/>
              <a:t>29/09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1706A9C-742F-46BF-94F0-8047D40D60A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A315510-953B-408D-8967-C03914021C5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8C10C5-4350-47AF-9CEE-A9845151BF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760565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4B0EEEE0-6DEE-0185-DC10-D20351B49B47}"/>
              </a:ext>
            </a:extLst>
          </p:cNvPr>
          <p:cNvSpPr txBox="1"/>
          <p:nvPr/>
        </p:nvSpPr>
        <p:spPr>
          <a:xfrm>
            <a:off x="338948" y="6377213"/>
            <a:ext cx="1254720" cy="3114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</a:t>
            </a:r>
            <a:endParaRPr lang="en-GB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Picture 2" descr="2015">
            <a:extLst>
              <a:ext uri="{FF2B5EF4-FFF2-40B4-BE49-F238E27FC236}">
                <a16:creationId xmlns:a16="http://schemas.microsoft.com/office/drawing/2014/main" id="{FFB59D2D-6FCF-CFBE-10C4-732E9833B03A}"/>
              </a:ext>
            </a:extLst>
          </p:cNvPr>
          <p:cNvPicPr preferRelativeResize="0">
            <a:picLocks noChangeArrowheads="1"/>
          </p:cNvPicPr>
          <p:nvPr/>
        </p:nvPicPr>
        <p:blipFill rotWithShape="1">
          <a:blip r:embed="rId2" cstate="print">
            <a:alphaModFix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132" t="15614" r="12450" b="22308"/>
          <a:stretch/>
        </p:blipFill>
        <p:spPr bwMode="auto">
          <a:xfrm>
            <a:off x="4422710" y="653143"/>
            <a:ext cx="3090327" cy="40689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437233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C285DC87-DF0E-68B3-CD50-8AFC411F0593}"/>
              </a:ext>
            </a:extLst>
          </p:cNvPr>
          <p:cNvSpPr txBox="1"/>
          <p:nvPr/>
        </p:nvSpPr>
        <p:spPr>
          <a:xfrm>
            <a:off x="338948" y="6377213"/>
            <a:ext cx="1254720" cy="3114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2</a:t>
            </a:r>
            <a:endParaRPr lang="en-GB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8" name="Immagine 7" descr="Immagine che contiene testo, diagramma&#10;&#10;Descrizione generata automaticamente">
            <a:extLst>
              <a:ext uri="{FF2B5EF4-FFF2-40B4-BE49-F238E27FC236}">
                <a16:creationId xmlns:a16="http://schemas.microsoft.com/office/drawing/2014/main" id="{140ABDCE-618B-C114-9999-AA760FA0252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44233" y="61808"/>
            <a:ext cx="6265824" cy="6052462"/>
          </a:xfrm>
          <a:prstGeom prst="rect">
            <a:avLst/>
          </a:prstGeom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6815189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afico 1">
            <a:extLst>
              <a:ext uri="{FF2B5EF4-FFF2-40B4-BE49-F238E27FC236}">
                <a16:creationId xmlns:a16="http://schemas.microsoft.com/office/drawing/2014/main" id="{07FA6C42-D926-783D-4A53-513176E83EE5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410409710"/>
              </p:ext>
            </p:extLst>
          </p:nvPr>
        </p:nvGraphicFramePr>
        <p:xfrm>
          <a:off x="2142312" y="435426"/>
          <a:ext cx="7907383" cy="544285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CasellaDiTesto 2">
            <a:extLst>
              <a:ext uri="{FF2B5EF4-FFF2-40B4-BE49-F238E27FC236}">
                <a16:creationId xmlns:a16="http://schemas.microsoft.com/office/drawing/2014/main" id="{1EE7CBF7-E930-48AB-8958-0902C1CEC4B6}"/>
              </a:ext>
            </a:extLst>
          </p:cNvPr>
          <p:cNvSpPr txBox="1"/>
          <p:nvPr/>
        </p:nvSpPr>
        <p:spPr>
          <a:xfrm>
            <a:off x="426034" y="6002744"/>
            <a:ext cx="1254720" cy="3114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3</a:t>
            </a:r>
            <a:endParaRPr lang="en-GB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9352150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8FEC20BB555E184BB64C998BDB2F4130" ma:contentTypeVersion="15" ma:contentTypeDescription="Creare un nuovo documento." ma:contentTypeScope="" ma:versionID="00666b7cca0f2557eaa956265bcc3003">
  <xsd:schema xmlns:xsd="http://www.w3.org/2001/XMLSchema" xmlns:xs="http://www.w3.org/2001/XMLSchema" xmlns:p="http://schemas.microsoft.com/office/2006/metadata/properties" xmlns:ns3="a2e4d7b7-8663-432f-96f8-e4f988192a3d" xmlns:ns4="9a66e226-79bd-4961-841b-77de6e66f199" targetNamespace="http://schemas.microsoft.com/office/2006/metadata/properties" ma:root="true" ma:fieldsID="e7817fdfcb3085f5b3571690c4111064" ns3:_="" ns4:_="">
    <xsd:import namespace="a2e4d7b7-8663-432f-96f8-e4f988192a3d"/>
    <xsd:import namespace="9a66e226-79bd-4961-841b-77de6e66f199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ServiceLocation" minOccurs="0"/>
                <xsd:element ref="ns3:MediaLengthInSeconds" minOccurs="0"/>
                <xsd:element ref="ns4:SharedWithUsers" minOccurs="0"/>
                <xsd:element ref="ns4:SharedWithDetails" minOccurs="0"/>
                <xsd:element ref="ns4:SharingHintHash" minOccurs="0"/>
                <xsd:element ref="ns3:_activity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2e4d7b7-8663-432f-96f8-e4f988192a3d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  <xsd:element name="MediaLengthInSeconds" ma:index="18" nillable="true" ma:displayName="Length (seconds)" ma:internalName="MediaLengthInSeconds" ma:readOnly="true">
      <xsd:simpleType>
        <xsd:restriction base="dms:Unknown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a66e226-79bd-4961-841b-77de6e66f199" elementFormDefault="qualified">
    <xsd:import namespace="http://schemas.microsoft.com/office/2006/documentManagement/types"/>
    <xsd:import namespace="http://schemas.microsoft.com/office/infopath/2007/PartnerControls"/>
    <xsd:element name="SharedWithUsers" ma:index="19" nillable="true" ma:displayName="Condiviso con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0" nillable="true" ma:displayName="Condiviso con dettagli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1" nillable="true" ma:displayName="Hash suggerimento condivisione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i contenuto"/>
        <xsd:element ref="dc:title" minOccurs="0" maxOccurs="1" ma:index="4" ma:displayName="Tito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a2e4d7b7-8663-432f-96f8-e4f988192a3d" xsi:nil="true"/>
  </documentManagement>
</p:properties>
</file>

<file path=customXml/itemProps1.xml><?xml version="1.0" encoding="utf-8"?>
<ds:datastoreItem xmlns:ds="http://schemas.openxmlformats.org/officeDocument/2006/customXml" ds:itemID="{E12BA9FF-E39F-4DFC-A92E-5219356C008A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B7E8C4BC-B508-4BED-9134-5447CFA7087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a2e4d7b7-8663-432f-96f8-e4f988192a3d"/>
    <ds:schemaRef ds:uri="9a66e226-79bd-4961-841b-77de6e66f19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3D9A2D4B-4BD6-4548-903E-66677F1F4CB7}">
  <ds:schemaRefs>
    <ds:schemaRef ds:uri="http://schemas.microsoft.com/office/2006/documentManagement/types"/>
    <ds:schemaRef ds:uri="http://schemas.microsoft.com/office/infopath/2007/PartnerControls"/>
    <ds:schemaRef ds:uri="http://www.w3.org/XML/1998/namespace"/>
    <ds:schemaRef ds:uri="9a66e226-79bd-4961-841b-77de6e66f199"/>
    <ds:schemaRef ds:uri="http://purl.org/dc/terms/"/>
    <ds:schemaRef ds:uri="http://schemas.microsoft.com/office/2006/metadata/properties"/>
    <ds:schemaRef ds:uri="a2e4d7b7-8663-432f-96f8-e4f988192a3d"/>
    <ds:schemaRef ds:uri="http://purl.org/dc/dcmitype/"/>
    <ds:schemaRef ds:uri="http://schemas.openxmlformats.org/package/2006/metadata/core-properties"/>
    <ds:schemaRef ds:uri="http://purl.org/dc/elements/1.1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352</TotalTime>
  <Words>23</Words>
  <Application>Microsoft Office PowerPoint</Application>
  <PresentationFormat>Widescreen</PresentationFormat>
  <Paragraphs>6</Paragraphs>
  <Slides>3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PAOLA CASTALDI</dc:creator>
  <cp:lastModifiedBy>DIQUATTRO Stefania</cp:lastModifiedBy>
  <cp:revision>4</cp:revision>
  <dcterms:created xsi:type="dcterms:W3CDTF">2023-05-29T15:12:06Z</dcterms:created>
  <dcterms:modified xsi:type="dcterms:W3CDTF">2023-09-29T09:56:1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8FEC20BB555E184BB64C998BDB2F4130</vt:lpwstr>
  </property>
</Properties>
</file>